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1" r:id="rId2"/>
  </p:sldIdLst>
  <p:sldSz cx="6858000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bius, R.E." initials="MR" lastIdx="3" clrIdx="0">
    <p:extLst>
      <p:ext uri="{19B8F6BF-5375-455C-9EA6-DF929625EA0E}">
        <p15:presenceInfo xmlns:p15="http://schemas.microsoft.com/office/powerpoint/2012/main" userId="Mebius, R.E.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849" autoAdjust="0"/>
  </p:normalViewPr>
  <p:slideViewPr>
    <p:cSldViewPr snapToGrid="0">
      <p:cViewPr>
        <p:scale>
          <a:sx n="90" d="100"/>
          <a:sy n="90" d="100"/>
        </p:scale>
        <p:origin x="1244" y="-39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C4BCAD-7083-4AC6-915D-09EFFFA2AC4E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589213" y="1143000"/>
            <a:ext cx="1679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00083C-B969-426B-AE02-90E5D84EF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8301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589213" y="1143000"/>
            <a:ext cx="1679575" cy="3086100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00083C-B969-426B-AE02-90E5D84EF53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75834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062083"/>
            <a:ext cx="5829300" cy="438666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617911"/>
            <a:ext cx="5143500" cy="304208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805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180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70833"/>
            <a:ext cx="1478756" cy="10677907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70833"/>
            <a:ext cx="4350544" cy="10677907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838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639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141251"/>
            <a:ext cx="5915025" cy="524124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432079"/>
            <a:ext cx="5915025" cy="27562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508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354163"/>
            <a:ext cx="2914650" cy="7994577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354163"/>
            <a:ext cx="2914650" cy="7994577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256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836"/>
            <a:ext cx="5915025" cy="2435415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088748"/>
            <a:ext cx="2901255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602496"/>
            <a:ext cx="2901255" cy="676957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088748"/>
            <a:ext cx="2915543" cy="151374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602496"/>
            <a:ext cx="2915543" cy="676957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742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78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14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814168"/>
            <a:ext cx="3471863" cy="89541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338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39999"/>
            <a:ext cx="2211884" cy="2939997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814168"/>
            <a:ext cx="3471863" cy="89541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779996"/>
            <a:ext cx="2211884" cy="700291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758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70836"/>
            <a:ext cx="5915025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354163"/>
            <a:ext cx="5915025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CF8159-7C6B-4665-B5C4-0251BD15A9D0}" type="datetimeFigureOut">
              <a:rPr lang="en-GB" smtClean="0"/>
              <a:t>05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678325"/>
            <a:ext cx="2314575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678325"/>
            <a:ext cx="1543050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384B4-B940-4EE4-9725-61FA24B493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240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fbeelding 3"/>
          <p:cNvPicPr/>
          <p:nvPr/>
        </p:nvPicPr>
        <p:blipFill>
          <a:blip r:embed="rId3"/>
          <a:stretch>
            <a:fillRect/>
          </a:stretch>
        </p:blipFill>
        <p:spPr>
          <a:xfrm>
            <a:off x="152400" y="2664595"/>
            <a:ext cx="2046632" cy="2043393"/>
          </a:xfrm>
          <a:prstGeom prst="rect">
            <a:avLst/>
          </a:prstGeom>
        </p:spPr>
      </p:pic>
      <p:pic>
        <p:nvPicPr>
          <p:cNvPr id="5" name="Afbeelding 4"/>
          <p:cNvPicPr/>
          <p:nvPr/>
        </p:nvPicPr>
        <p:blipFill>
          <a:blip r:embed="rId4"/>
          <a:stretch>
            <a:fillRect/>
          </a:stretch>
        </p:blipFill>
        <p:spPr>
          <a:xfrm>
            <a:off x="279682" y="6576142"/>
            <a:ext cx="2049799" cy="3969608"/>
          </a:xfrm>
          <a:prstGeom prst="rect">
            <a:avLst/>
          </a:prstGeom>
        </p:spPr>
      </p:pic>
      <p:pic>
        <p:nvPicPr>
          <p:cNvPr id="6" name="Afbeelding 5"/>
          <p:cNvPicPr/>
          <p:nvPr/>
        </p:nvPicPr>
        <p:blipFill>
          <a:blip r:embed="rId5"/>
          <a:stretch>
            <a:fillRect/>
          </a:stretch>
        </p:blipFill>
        <p:spPr>
          <a:xfrm>
            <a:off x="2414162" y="2664594"/>
            <a:ext cx="3012141" cy="2322594"/>
          </a:xfrm>
          <a:prstGeom prst="rect">
            <a:avLst/>
          </a:prstGeom>
        </p:spPr>
      </p:pic>
      <p:pic>
        <p:nvPicPr>
          <p:cNvPr id="8" name="Afbeelding 7"/>
          <p:cNvPicPr/>
          <p:nvPr/>
        </p:nvPicPr>
        <p:blipFill>
          <a:blip r:embed="rId6"/>
          <a:stretch>
            <a:fillRect/>
          </a:stretch>
        </p:blipFill>
        <p:spPr>
          <a:xfrm>
            <a:off x="3159706" y="8536490"/>
            <a:ext cx="3499564" cy="2389529"/>
          </a:xfrm>
          <a:prstGeom prst="rect">
            <a:avLst/>
          </a:prstGeom>
        </p:spPr>
      </p:pic>
      <p:sp>
        <p:nvSpPr>
          <p:cNvPr id="9" name="Tekstvak 8"/>
          <p:cNvSpPr txBox="1"/>
          <p:nvPr/>
        </p:nvSpPr>
        <p:spPr>
          <a:xfrm>
            <a:off x="152400" y="4763222"/>
            <a:ext cx="204663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43">
              <a:defRPr/>
            </a:pP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uman monocytes were differentiated with IL-4 and GM-CSF for 7 days into monocyte-derived dendritic cells. Cells were cultured in the presence of RE- or RA-click for 1 hour. Vehicle treated cells were taken along as a negative control.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cleus (blue) and probes (green) were visualized for microscopic analysis.</a:t>
            </a:r>
            <a:endParaRPr lang="nl-NL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kstvak 9"/>
          <p:cNvSpPr txBox="1"/>
          <p:nvPr/>
        </p:nvSpPr>
        <p:spPr>
          <a:xfrm>
            <a:off x="0" y="10509022"/>
            <a:ext cx="2630412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43">
              <a:defRPr/>
            </a:pP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Whole blood was lysed to remove erythrocytes and the remaining cells were fixed and subsequently stained with a viability dye, anti-CD3 PE, anti-CD16 APC-ef780 and anti-CD56 for flow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ic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(A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 versus side scatter plots of samples treated with copper-facilitated click mix or without copper. Lymphocytes, monocytes and granulocytes were gated based on scatter profile. (B) Gating strategy for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-PE, CD16-APC-ef780 and CD56 positive cells after treatment with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pper-facilitated click mix or without copper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kstvak 10"/>
          <p:cNvSpPr txBox="1"/>
          <p:nvPr/>
        </p:nvSpPr>
        <p:spPr>
          <a:xfrm>
            <a:off x="5393594" y="2662006"/>
            <a:ext cx="1333662" cy="5016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43">
              <a:defRPr/>
            </a:pP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Human total B cells cannot produce retinoic acid, but can take up exogenous </a:t>
            </a:r>
            <a:r>
              <a:rPr lang="en-GB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inoids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uman CD19</a:t>
            </a:r>
            <a:r>
              <a:rPr lang="en-GB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were isolated from blood. (A) Representative dot plot of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defluor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F) positivity in B cells. DEAB reagent was used as a negative control. (B) Quantification of </a:t>
            </a:r>
            <a:r>
              <a:rPr lang="en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defluor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F) positivity in B cells (n=3). (C) Representative histogram of the uptake of RE-click (pink) and RA-click (blue) in B cells compared to vehicle control (dotted line). (D) Quantification of the uptake of RE-click and RA-click in B cells compared to vehicle control (n=3). Data are presented as mean ± SD. </a:t>
            </a:r>
          </a:p>
        </p:txBody>
      </p:sp>
      <p:sp>
        <p:nvSpPr>
          <p:cNvPr id="12" name="Tekstvak 11"/>
          <p:cNvSpPr txBox="1"/>
          <p:nvPr/>
        </p:nvSpPr>
        <p:spPr>
          <a:xfrm>
            <a:off x="2630412" y="7520828"/>
            <a:ext cx="28613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43">
              <a:defRPr/>
            </a:pP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naïve B cells were isolated from blood and cultured within the presence of the RE- or RA-click for 1 hour. Vehicle treated cells were taken along as a negative control.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cleus (blue) and probes (green) were visualized for microscopic analysis.</a:t>
            </a:r>
            <a:endParaRPr lang="nl-NL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kstvak 12"/>
          <p:cNvSpPr txBox="1"/>
          <p:nvPr/>
        </p:nvSpPr>
        <p:spPr>
          <a:xfrm>
            <a:off x="3159707" y="10995662"/>
            <a:ext cx="349956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: Naïve B cells enhance IgA expression when stimulated with retinoic acid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uman naïve B cells were isolated from peripheral blood and cultured in the presence of T cell dependent (TD) stimuli for 7 days ,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ing interleukin-4, anti-CD40 and anti-IgM antibodies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Dot plots of B cells gated on immunoglobulin A cultured with retinoic acid, RA-click and vehicle. Quantification of (B) the mean fluorescent intensity (MFI) and (C) percentages of IgA expressing B cells (n=3). Data are presented as mean ± SD. N.s= not significant. </a:t>
            </a:r>
          </a:p>
        </p:txBody>
      </p:sp>
      <p:sp>
        <p:nvSpPr>
          <p:cNvPr id="16" name="Rechthoek 15"/>
          <p:cNvSpPr/>
          <p:nvPr/>
        </p:nvSpPr>
        <p:spPr>
          <a:xfrm>
            <a:off x="42644" y="2594748"/>
            <a:ext cx="2178452" cy="39601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hthoek 16"/>
          <p:cNvSpPr/>
          <p:nvPr/>
        </p:nvSpPr>
        <p:spPr>
          <a:xfrm>
            <a:off x="43216" y="6556426"/>
            <a:ext cx="2551409" cy="6031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hthoek 20"/>
          <p:cNvSpPr/>
          <p:nvPr/>
        </p:nvSpPr>
        <p:spPr>
          <a:xfrm>
            <a:off x="2221095" y="2589431"/>
            <a:ext cx="3205205" cy="24722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hthoek 21"/>
          <p:cNvSpPr/>
          <p:nvPr/>
        </p:nvSpPr>
        <p:spPr>
          <a:xfrm>
            <a:off x="5428400" y="2586113"/>
            <a:ext cx="1331564" cy="50926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hthoek 22"/>
          <p:cNvSpPr/>
          <p:nvPr/>
        </p:nvSpPr>
        <p:spPr>
          <a:xfrm>
            <a:off x="5343276" y="2641692"/>
            <a:ext cx="148438" cy="2390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5" name="Rechte verbindingslijn 24"/>
          <p:cNvCxnSpPr/>
          <p:nvPr/>
        </p:nvCxnSpPr>
        <p:spPr>
          <a:xfrm>
            <a:off x="2594625" y="8513003"/>
            <a:ext cx="3519928" cy="58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Rechte verbindingslijn 29"/>
          <p:cNvCxnSpPr>
            <a:stCxn id="22" idx="2"/>
          </p:cNvCxnSpPr>
          <p:nvPr/>
        </p:nvCxnSpPr>
        <p:spPr>
          <a:xfrm>
            <a:off x="6094182" y="7678764"/>
            <a:ext cx="20372" cy="81976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32" name="Afbeelding 3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69" b="8232"/>
          <a:stretch/>
        </p:blipFill>
        <p:spPr>
          <a:xfrm>
            <a:off x="2721908" y="5109845"/>
            <a:ext cx="2621368" cy="2425127"/>
          </a:xfrm>
          <a:prstGeom prst="rect">
            <a:avLst/>
          </a:prstGeom>
        </p:spPr>
      </p:pic>
      <p:sp>
        <p:nvSpPr>
          <p:cNvPr id="41" name="Tekstvak 40"/>
          <p:cNvSpPr txBox="1"/>
          <p:nvPr/>
        </p:nvSpPr>
        <p:spPr>
          <a:xfrm>
            <a:off x="16226" y="78145"/>
            <a:ext cx="225092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Figure 1: Clickable </a:t>
            </a:r>
            <a:r>
              <a:rPr lang="en-GB" sz="1000" b="1" dirty="0" err="1"/>
              <a:t>retinoids</a:t>
            </a:r>
            <a:r>
              <a:rPr lang="en-GB" sz="1000" b="1" dirty="0"/>
              <a:t> accumulate in multiple immune cell populations</a:t>
            </a:r>
            <a:r>
              <a:rPr lang="en-GB" sz="1000" dirty="0"/>
              <a:t>. </a:t>
            </a:r>
            <a:r>
              <a:rPr lang="nl-NL" sz="1000" dirty="0" err="1"/>
              <a:t>Whole</a:t>
            </a:r>
            <a:r>
              <a:rPr lang="nl-NL" sz="1000" dirty="0"/>
              <a:t> </a:t>
            </a:r>
            <a:r>
              <a:rPr lang="nl-NL" sz="1000" dirty="0" err="1"/>
              <a:t>white</a:t>
            </a:r>
            <a:r>
              <a:rPr lang="nl-NL" sz="1000" dirty="0"/>
              <a:t> </a:t>
            </a:r>
            <a:r>
              <a:rPr lang="nl-NL" sz="1000" dirty="0" err="1"/>
              <a:t>blood</a:t>
            </a:r>
            <a:r>
              <a:rPr lang="nl-NL" sz="1000" dirty="0"/>
              <a:t> </a:t>
            </a:r>
            <a:r>
              <a:rPr lang="nl-NL" sz="1000" dirty="0" err="1"/>
              <a:t>cells</a:t>
            </a:r>
            <a:r>
              <a:rPr lang="nl-NL" sz="1000" dirty="0"/>
              <a:t> </a:t>
            </a:r>
            <a:r>
              <a:rPr lang="nl-NL" sz="1000" dirty="0" err="1"/>
              <a:t>were</a:t>
            </a:r>
            <a:r>
              <a:rPr lang="nl-NL" sz="1000" dirty="0"/>
              <a:t> </a:t>
            </a:r>
            <a:r>
              <a:rPr lang="nl-NL" sz="1000" dirty="0" err="1"/>
              <a:t>incubated</a:t>
            </a:r>
            <a:r>
              <a:rPr lang="nl-NL" sz="1000" dirty="0"/>
              <a:t> </a:t>
            </a:r>
            <a:r>
              <a:rPr lang="nl-NL" sz="1000" dirty="0" err="1"/>
              <a:t>for</a:t>
            </a:r>
            <a:r>
              <a:rPr lang="nl-NL" sz="1000" dirty="0"/>
              <a:t> 1 </a:t>
            </a:r>
            <a:r>
              <a:rPr lang="nl-NL" sz="1000" dirty="0" err="1"/>
              <a:t>hour</a:t>
            </a:r>
            <a:r>
              <a:rPr lang="nl-NL" sz="1000" dirty="0"/>
              <a:t> at 37°C </a:t>
            </a:r>
            <a:r>
              <a:rPr lang="nl-NL" sz="1000" dirty="0" err="1"/>
              <a:t>with</a:t>
            </a:r>
            <a:r>
              <a:rPr lang="nl-NL" sz="1000" dirty="0"/>
              <a:t> RE- </a:t>
            </a:r>
            <a:r>
              <a:rPr lang="nl-NL" sz="1000" dirty="0" err="1"/>
              <a:t>and</a:t>
            </a:r>
            <a:r>
              <a:rPr lang="nl-NL" sz="1000" dirty="0"/>
              <a:t> RA-click </a:t>
            </a:r>
            <a:r>
              <a:rPr lang="nl-NL" sz="1000" dirty="0" err="1"/>
              <a:t>probes</a:t>
            </a:r>
            <a:r>
              <a:rPr lang="nl-NL" sz="1000" dirty="0"/>
              <a:t> </a:t>
            </a:r>
            <a:r>
              <a:rPr lang="nl-NL" sz="1000" dirty="0" err="1"/>
              <a:t>after</a:t>
            </a:r>
            <a:r>
              <a:rPr lang="nl-NL" sz="1000" dirty="0"/>
              <a:t> </a:t>
            </a:r>
            <a:r>
              <a:rPr lang="nl-NL" sz="1000" dirty="0" err="1"/>
              <a:t>which</a:t>
            </a:r>
            <a:r>
              <a:rPr lang="nl-NL" sz="1000" dirty="0"/>
              <a:t> </a:t>
            </a:r>
            <a:r>
              <a:rPr lang="nl-NL" sz="1000" dirty="0" err="1"/>
              <a:t>the</a:t>
            </a:r>
            <a:r>
              <a:rPr lang="nl-NL" sz="1000" dirty="0"/>
              <a:t> </a:t>
            </a:r>
            <a:r>
              <a:rPr lang="nl-NL" sz="1000" dirty="0" err="1"/>
              <a:t>uptake</a:t>
            </a:r>
            <a:r>
              <a:rPr lang="nl-NL" sz="1000" dirty="0"/>
              <a:t> of </a:t>
            </a:r>
            <a:r>
              <a:rPr lang="nl-NL" sz="1000" dirty="0" err="1"/>
              <a:t>the</a:t>
            </a:r>
            <a:r>
              <a:rPr lang="nl-NL" sz="1000" dirty="0"/>
              <a:t> </a:t>
            </a:r>
            <a:r>
              <a:rPr lang="nl-NL" sz="1000" dirty="0" err="1"/>
              <a:t>probes</a:t>
            </a:r>
            <a:r>
              <a:rPr lang="nl-NL" sz="1000" dirty="0"/>
              <a:t> was </a:t>
            </a:r>
            <a:r>
              <a:rPr lang="nl-NL" sz="1000" dirty="0" err="1"/>
              <a:t>determined</a:t>
            </a:r>
            <a:r>
              <a:rPr lang="nl-NL" sz="1000" dirty="0"/>
              <a:t> in different </a:t>
            </a:r>
            <a:r>
              <a:rPr lang="nl-NL" sz="1000" dirty="0" err="1"/>
              <a:t>cell</a:t>
            </a:r>
            <a:r>
              <a:rPr lang="nl-NL" sz="1000" dirty="0"/>
              <a:t> subsets (A) </a:t>
            </a:r>
            <a:r>
              <a:rPr lang="nl-NL" sz="1000" dirty="0" err="1"/>
              <a:t>based</a:t>
            </a:r>
            <a:r>
              <a:rPr lang="nl-NL" sz="1000" dirty="0"/>
              <a:t> on forward side </a:t>
            </a:r>
            <a:r>
              <a:rPr lang="nl-NL" sz="1000" dirty="0" err="1"/>
              <a:t>scatter</a:t>
            </a:r>
            <a:r>
              <a:rPr lang="nl-NL" sz="1000" dirty="0"/>
              <a:t> profile. </a:t>
            </a:r>
            <a:r>
              <a:rPr lang="en-GB" sz="1000" dirty="0"/>
              <a:t>Based on gating indicated in (A) the uptake of (B-D) RE-click and (E-F) RA-click (blue)  in (B, E) granulocytes, (C, F) monocytes and (D, G) lymphocytes was compared to vehicle control (dotted line). </a:t>
            </a:r>
            <a:endParaRPr lang="nl-NL" sz="1000" dirty="0"/>
          </a:p>
          <a:p>
            <a:pPr algn="just"/>
            <a:endParaRPr lang="en-GB" sz="1000" dirty="0"/>
          </a:p>
        </p:txBody>
      </p:sp>
      <p:pic>
        <p:nvPicPr>
          <p:cNvPr id="43" name="Afbeelding 4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8357" y="62288"/>
            <a:ext cx="4448873" cy="2494427"/>
          </a:xfrm>
          <a:prstGeom prst="rect">
            <a:avLst/>
          </a:prstGeom>
        </p:spPr>
      </p:pic>
      <p:sp>
        <p:nvSpPr>
          <p:cNvPr id="45" name="Rechthoek 44"/>
          <p:cNvSpPr/>
          <p:nvPr/>
        </p:nvSpPr>
        <p:spPr>
          <a:xfrm>
            <a:off x="42533" y="0"/>
            <a:ext cx="6767341" cy="25861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285346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0</Words>
  <Application>Microsoft Office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Kantoorthema</vt:lpstr>
      <vt:lpstr>PowerPoint Presentation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Bos et al</dc:title>
  <dc:creator>Bos, A.V. (Amélie)</dc:creator>
  <cp:lastModifiedBy>Megan Bond</cp:lastModifiedBy>
  <cp:revision>29</cp:revision>
  <dcterms:created xsi:type="dcterms:W3CDTF">2021-02-12T15:31:46Z</dcterms:created>
  <dcterms:modified xsi:type="dcterms:W3CDTF">2021-07-05T09:55:39Z</dcterms:modified>
</cp:coreProperties>
</file>